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7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49ED2"/>
    <a:srgbClr val="1A479E"/>
    <a:srgbClr val="FC8D59"/>
    <a:srgbClr val="91BFDB"/>
    <a:srgbClr val="F8766D"/>
    <a:srgbClr val="5ADDFE"/>
    <a:srgbClr val="56C5D4"/>
    <a:srgbClr val="EEEE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711" autoAdjust="0"/>
  </p:normalViewPr>
  <p:slideViewPr>
    <p:cSldViewPr snapToGrid="0">
      <p:cViewPr>
        <p:scale>
          <a:sx n="232" d="100"/>
          <a:sy n="232" d="100"/>
        </p:scale>
        <p:origin x="-204" y="-43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F1877C-87EF-46DC-99F9-8F6F7C731258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210EEB-8E35-448A-970E-9E5DD1DA72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8112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9496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066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774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4041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0322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7746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3454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0752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4720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3566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0796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195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DE0831-E557-BD9D-57E8-B320ED13ACD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346D04B-0F05-8D4D-B0C4-4CA64AB11784}"/>
              </a:ext>
            </a:extLst>
          </p:cNvPr>
          <p:cNvSpPr txBox="1"/>
          <p:nvPr/>
        </p:nvSpPr>
        <p:spPr>
          <a:xfrm>
            <a:off x="3169456" y="100512"/>
            <a:ext cx="355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FE51F45-8323-564B-02F1-5E59D6D7A92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22" r="15476"/>
          <a:stretch/>
        </p:blipFill>
        <p:spPr bwMode="auto">
          <a:xfrm>
            <a:off x="323139" y="561127"/>
            <a:ext cx="2492968" cy="26993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AFA358DE-FDE7-3C6C-7EB6-5E1E43BB02A0}"/>
              </a:ext>
            </a:extLst>
          </p:cNvPr>
          <p:cNvSpPr txBox="1"/>
          <p:nvPr/>
        </p:nvSpPr>
        <p:spPr>
          <a:xfrm>
            <a:off x="309990" y="3327840"/>
            <a:ext cx="61670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 | Microbiome diversity</a:t>
            </a:r>
            <a:r>
              <a:rPr lang="en-GB" sz="7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PCA 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lot illustrating the </a:t>
            </a:r>
            <a:r>
              <a:rPr lang="en-GB" sz="700" dirty="0" err="1">
                <a:latin typeface="Arial" panose="020B0604020202020204" pitchFamily="34" charset="0"/>
                <a:cs typeface="Arial" panose="020B0604020202020204" pitchFamily="34" charset="0"/>
              </a:rPr>
              <a:t>centered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 log-ratio (CLR) transformation of taxonomic relative abundances for each sample, visualized in Euclidean space to assess β-diversity.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739FF0D9-3078-BEC5-AD11-990842D0F71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307" t="47128" r="9424" b="45986"/>
          <a:stretch/>
        </p:blipFill>
        <p:spPr bwMode="auto">
          <a:xfrm>
            <a:off x="2816107" y="1643984"/>
            <a:ext cx="216956" cy="3501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Grupo 6">
            <a:extLst>
              <a:ext uri="{FF2B5EF4-FFF2-40B4-BE49-F238E27FC236}">
                <a16:creationId xmlns:a16="http://schemas.microsoft.com/office/drawing/2014/main" id="{4C6315DF-441C-4D5F-9705-6AF0B3EEE4E6}"/>
              </a:ext>
            </a:extLst>
          </p:cNvPr>
          <p:cNvGrpSpPr/>
          <p:nvPr/>
        </p:nvGrpSpPr>
        <p:grpSpPr>
          <a:xfrm>
            <a:off x="2911360" y="1656910"/>
            <a:ext cx="1236612" cy="361988"/>
            <a:chOff x="138450" y="2178533"/>
            <a:chExt cx="1236612" cy="361988"/>
          </a:xfrm>
        </p:grpSpPr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62D88603-ABF1-2A2F-259F-2EBE8CFEA70D}"/>
                </a:ext>
              </a:extLst>
            </p:cNvPr>
            <p:cNvSpPr txBox="1"/>
            <p:nvPr/>
          </p:nvSpPr>
          <p:spPr>
            <a:xfrm>
              <a:off x="138450" y="2178533"/>
              <a:ext cx="12366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M116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03D92C0-48D4-40A9-429F-305CFA64A71C}"/>
                </a:ext>
              </a:extLst>
            </p:cNvPr>
            <p:cNvSpPr txBox="1"/>
            <p:nvPr/>
          </p:nvSpPr>
          <p:spPr>
            <a:xfrm>
              <a:off x="138450" y="2355855"/>
              <a:ext cx="102591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trl Wome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025198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539</TotalTime>
  <Words>41</Words>
  <Application>Microsoft Office PowerPoint</Application>
  <PresentationFormat>A4 (210 x 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loy Santos</dc:creator>
  <cp:lastModifiedBy>Eloy Santos</cp:lastModifiedBy>
  <cp:revision>330</cp:revision>
  <cp:lastPrinted>2024-12-23T09:31:56Z</cp:lastPrinted>
  <dcterms:created xsi:type="dcterms:W3CDTF">2024-03-13T15:19:51Z</dcterms:created>
  <dcterms:modified xsi:type="dcterms:W3CDTF">2025-02-17T15:01:57Z</dcterms:modified>
</cp:coreProperties>
</file>